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50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8CA32-7C32-4925-9601-8950BF748117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2179E-5040-4981-B9FE-3994BDD93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8259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8CA32-7C32-4925-9601-8950BF748117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2179E-5040-4981-B9FE-3994BDD93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7918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8CA32-7C32-4925-9601-8950BF748117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2179E-5040-4981-B9FE-3994BDD93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90785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8CA32-7C32-4925-9601-8950BF748117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2179E-5040-4981-B9FE-3994BDD93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83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8CA32-7C32-4925-9601-8950BF748117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2179E-5040-4981-B9FE-3994BDD93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611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8CA32-7C32-4925-9601-8950BF748117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2179E-5040-4981-B9FE-3994BDD93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0047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8CA32-7C32-4925-9601-8950BF748117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2179E-5040-4981-B9FE-3994BDD93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579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8CA32-7C32-4925-9601-8950BF748117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2179E-5040-4981-B9FE-3994BDD93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32322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8CA32-7C32-4925-9601-8950BF748117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2179E-5040-4981-B9FE-3994BDD93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208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8CA32-7C32-4925-9601-8950BF748117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2179E-5040-4981-B9FE-3994BDD93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21998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8CA32-7C32-4925-9601-8950BF748117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2179E-5040-4981-B9FE-3994BDD93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2459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F8CA32-7C32-4925-9601-8950BF748117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52179E-5040-4981-B9FE-3994BDD93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970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119674" y="779206"/>
            <a:ext cx="9797143" cy="50783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b="1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2 Fig. </a:t>
            </a:r>
            <a:r>
              <a:rPr lang="en-US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Unconditioned and conditional analysis of HLA alleles and residues. Genomic position coordinates are presented as </a:t>
            </a:r>
            <a:r>
              <a:rPr lang="en-US" dirty="0" err="1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gabases</a:t>
            </a:r>
            <a:r>
              <a:rPr lang="en-US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for the hg19 genomic build. SNPs are presented in black, Residues (AA) are presented in red, and alleles in blue.</a:t>
            </a:r>
            <a:r>
              <a:rPr lang="en-US" b="1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ines for genome-wide association (P&lt;5x10</a:t>
            </a:r>
            <a:r>
              <a:rPr lang="en-US" baseline="300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8</a:t>
            </a:r>
            <a:r>
              <a:rPr lang="en-US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in red, and for suggestive association (P&lt;5x10</a:t>
            </a:r>
            <a:r>
              <a:rPr lang="en-US" baseline="300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5</a:t>
            </a:r>
            <a:r>
              <a:rPr lang="en-US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in green. </a:t>
            </a:r>
            <a:r>
              <a:rPr lang="en-US" b="1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. Unconditioned omnibus analysis. Conditional analysis. </a:t>
            </a:r>
            <a:r>
              <a:rPr lang="en-US" b="1" dirty="0" err="1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.</a:t>
            </a:r>
            <a:r>
              <a:rPr lang="en-US" b="1" dirty="0" err="1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onditioning</a:t>
            </a:r>
            <a:r>
              <a:rPr lang="en-US" b="1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for the effect of DBR1 11+DRB1-13 residues. C. Conditioning for the effect of DBR1 11+DRB1-13+ DRB1-37 residues. D. Conditioning for the effect of DBR1 alleles. E. Conditioning for the effect of DBR1 alleles + A-70 residue. F. Conditioning for the effect of DBR1 +A alleles. G. Conditioning for the effect of DBR1 +A alleles + DPB1-35 residue. H. Conditioning for the effect of DBR1 +A +DPB1 alleles. I. Conditioning for the effect of DBR1 +A +DPB1 alleles + DQB1-37. J. Conditioning for the effect of DBR1 +A +DPB1 +DQB1 alleles. K. Conditioning for the effect of DBR1 +A +DPB1 +DQB1 alleles + B-9. L. Conditioning for the effect of DBR1 +A +DPB1 +DQB1 +B alleles.</a:t>
            </a:r>
            <a:endParaRPr lang="en-US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740075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432358"/>
            <a:ext cx="12192000" cy="599328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63026"/>
            <a:ext cx="88430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2i Fig</a:t>
            </a:r>
            <a:r>
              <a:rPr lang="en-US" b="1" dirty="0"/>
              <a:t>.</a:t>
            </a:r>
            <a:r>
              <a:rPr lang="en-US" dirty="0" smtClean="0"/>
              <a:t> </a:t>
            </a:r>
            <a:r>
              <a:rPr lang="en-US" dirty="0"/>
              <a:t>Conditional analysis. Conditioning for the effect of DBR1 +A +DPB1 </a:t>
            </a:r>
            <a:r>
              <a:rPr lang="en-US" dirty="0" smtClean="0"/>
              <a:t>alleles + DQB1-37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0402322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432358"/>
            <a:ext cx="12192000" cy="599328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63026"/>
            <a:ext cx="84358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2j Fig</a:t>
            </a:r>
            <a:r>
              <a:rPr lang="en-US" b="1" dirty="0"/>
              <a:t>.</a:t>
            </a:r>
            <a:r>
              <a:rPr lang="en-US" dirty="0" smtClean="0"/>
              <a:t> </a:t>
            </a:r>
            <a:r>
              <a:rPr lang="en-US" dirty="0"/>
              <a:t>Conditional analysis. Conditioning for the effect of DBR1 +A +</a:t>
            </a:r>
            <a:r>
              <a:rPr lang="en-US" dirty="0" smtClean="0"/>
              <a:t>DPB1 +DQB1 </a:t>
            </a:r>
            <a:r>
              <a:rPr lang="en-US" dirty="0"/>
              <a:t>alleles</a:t>
            </a:r>
          </a:p>
        </p:txBody>
      </p:sp>
    </p:spTree>
    <p:extLst>
      <p:ext uri="{BB962C8B-B14F-4D97-AF65-F5344CB8AC3E}">
        <p14:creationId xmlns:p14="http://schemas.microsoft.com/office/powerpoint/2010/main" val="344181098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432358"/>
            <a:ext cx="12192000" cy="599328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63026"/>
            <a:ext cx="9020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2k Fig</a:t>
            </a:r>
            <a:r>
              <a:rPr lang="en-US" b="1" dirty="0"/>
              <a:t>.</a:t>
            </a:r>
            <a:r>
              <a:rPr lang="en-US" dirty="0" smtClean="0"/>
              <a:t> </a:t>
            </a:r>
            <a:r>
              <a:rPr lang="en-US" dirty="0"/>
              <a:t>Conditional analysis. Conditioning for the effect of DBR1 +A +DPB1 +DQB1 </a:t>
            </a:r>
            <a:r>
              <a:rPr lang="en-US" dirty="0" smtClean="0"/>
              <a:t>alleles + B-9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3499900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432358"/>
            <a:ext cx="12192000" cy="599328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63026"/>
            <a:ext cx="87789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2l Fig</a:t>
            </a:r>
            <a:r>
              <a:rPr lang="en-US" b="1" dirty="0"/>
              <a:t>.</a:t>
            </a:r>
            <a:r>
              <a:rPr lang="en-US" dirty="0" smtClean="0"/>
              <a:t> </a:t>
            </a:r>
            <a:r>
              <a:rPr lang="en-US" dirty="0"/>
              <a:t>Conditional analysis. Conditioning for the effect of DBR1 +A +DPB1 +DQB1 </a:t>
            </a:r>
            <a:r>
              <a:rPr lang="en-US" dirty="0" smtClean="0"/>
              <a:t>+B allel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47162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674956"/>
            <a:ext cx="12192000" cy="5993284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" y="63025"/>
            <a:ext cx="1195251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2a Fig</a:t>
            </a:r>
            <a:r>
              <a:rPr lang="en-US" b="1" dirty="0"/>
              <a:t>.</a:t>
            </a:r>
            <a:r>
              <a:rPr lang="en-US" dirty="0" smtClean="0"/>
              <a:t> Unconditioned omnibus analysis. Genomic position coordinates are presented as </a:t>
            </a:r>
            <a:r>
              <a:rPr lang="en-US" dirty="0" err="1" smtClean="0"/>
              <a:t>megabases</a:t>
            </a:r>
            <a:r>
              <a:rPr lang="en-US" dirty="0" smtClean="0"/>
              <a:t> for the hg19 genomic build. SNPs are presented in black, Residues (AA) are presented in </a:t>
            </a:r>
            <a:r>
              <a:rPr lang="en-US" dirty="0" smtClean="0">
                <a:solidFill>
                  <a:srgbClr val="FF0000"/>
                </a:solidFill>
              </a:rPr>
              <a:t>red</a:t>
            </a:r>
            <a:r>
              <a:rPr lang="en-US" dirty="0" smtClean="0"/>
              <a:t>, and alleles in </a:t>
            </a:r>
            <a:r>
              <a:rPr lang="en-US" dirty="0" smtClean="0">
                <a:solidFill>
                  <a:srgbClr val="0070C0"/>
                </a:solidFill>
              </a:rPr>
              <a:t>blue</a:t>
            </a:r>
            <a:r>
              <a:rPr lang="en-US" dirty="0" smtClean="0"/>
              <a:t>. </a:t>
            </a:r>
            <a:r>
              <a:rPr lang="en-US" dirty="0"/>
              <a:t>Lines for genomewide association (P&lt;5x10</a:t>
            </a:r>
            <a:r>
              <a:rPr lang="en-US" baseline="30000" dirty="0"/>
              <a:t>-8</a:t>
            </a:r>
            <a:r>
              <a:rPr lang="en-US" dirty="0"/>
              <a:t>) in red, and for suggestive association (P&lt;5x10</a:t>
            </a:r>
            <a:r>
              <a:rPr lang="en-US" baseline="30000" dirty="0"/>
              <a:t>-5</a:t>
            </a:r>
            <a:r>
              <a:rPr lang="en-US" dirty="0"/>
              <a:t>) in green.</a:t>
            </a:r>
          </a:p>
        </p:txBody>
      </p:sp>
    </p:spTree>
    <p:extLst>
      <p:ext uri="{BB962C8B-B14F-4D97-AF65-F5344CB8AC3E}">
        <p14:creationId xmlns:p14="http://schemas.microsoft.com/office/powerpoint/2010/main" val="31609476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432358"/>
            <a:ext cx="12192000" cy="599328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63026"/>
            <a:ext cx="8287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2b Fig</a:t>
            </a:r>
            <a:r>
              <a:rPr lang="en-US" b="1" dirty="0"/>
              <a:t>. </a:t>
            </a:r>
            <a:r>
              <a:rPr lang="en-US" dirty="0" smtClean="0"/>
              <a:t>Conditional analysis. Conditioning for the effect of DBR1 11+DRB1-13 residue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28093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432358"/>
            <a:ext cx="12192000" cy="599328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63026"/>
            <a:ext cx="92424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2c Fig</a:t>
            </a:r>
            <a:r>
              <a:rPr lang="en-US" b="1" dirty="0"/>
              <a:t>. </a:t>
            </a:r>
            <a:r>
              <a:rPr lang="en-US" dirty="0" smtClean="0"/>
              <a:t>Conditional analysis. Conditioning for the effect of DBR1 11+DRB1-13+ DRB1-37 residue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75432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432358"/>
            <a:ext cx="12192000" cy="599328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63026"/>
            <a:ext cx="68761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2d Fig</a:t>
            </a:r>
            <a:r>
              <a:rPr lang="en-US" b="1" dirty="0"/>
              <a:t>. </a:t>
            </a:r>
            <a:r>
              <a:rPr lang="en-US" dirty="0"/>
              <a:t>Conditional analysis. Conditioning for the effect of DBR1 </a:t>
            </a:r>
            <a:r>
              <a:rPr lang="en-US" dirty="0" smtClean="0"/>
              <a:t>alleles.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1024321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432358"/>
            <a:ext cx="12192000" cy="599328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63026"/>
            <a:ext cx="8274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2e Fig</a:t>
            </a:r>
            <a:r>
              <a:rPr lang="en-US" b="1" dirty="0"/>
              <a:t>.</a:t>
            </a:r>
            <a:r>
              <a:rPr lang="en-US" dirty="0" smtClean="0"/>
              <a:t> </a:t>
            </a:r>
            <a:r>
              <a:rPr lang="en-US" dirty="0"/>
              <a:t>Conditional analysis. Conditioning for the effect of DBR1 </a:t>
            </a:r>
            <a:r>
              <a:rPr lang="en-US" dirty="0" smtClean="0"/>
              <a:t>alleles + A-70 residue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8283924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432358"/>
            <a:ext cx="12192000" cy="599328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63026"/>
            <a:ext cx="7070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2f Fig</a:t>
            </a:r>
            <a:r>
              <a:rPr lang="en-US" b="1" dirty="0"/>
              <a:t>. </a:t>
            </a:r>
            <a:r>
              <a:rPr lang="en-US" dirty="0"/>
              <a:t>Conditional analysis. Conditioning for the effect of DBR1 </a:t>
            </a:r>
            <a:r>
              <a:rPr lang="en-US" dirty="0" smtClean="0"/>
              <a:t>+A allel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25056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432358"/>
            <a:ext cx="12192000" cy="599328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63026"/>
            <a:ext cx="8881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2g Fig</a:t>
            </a:r>
            <a:r>
              <a:rPr lang="en-US" b="1" dirty="0"/>
              <a:t>.</a:t>
            </a:r>
            <a:r>
              <a:rPr lang="en-US" dirty="0" smtClean="0"/>
              <a:t> </a:t>
            </a:r>
            <a:r>
              <a:rPr lang="en-US" dirty="0"/>
              <a:t>Conditional analysis. Conditioning for the effect of DBR1 +A </a:t>
            </a:r>
            <a:r>
              <a:rPr lang="en-US" dirty="0" smtClean="0"/>
              <a:t>alleles + DPB1-35 residu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6522077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432358"/>
            <a:ext cx="12192000" cy="599328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63026"/>
            <a:ext cx="7791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2h Fig</a:t>
            </a:r>
            <a:r>
              <a:rPr lang="en-US" b="1" dirty="0"/>
              <a:t>.</a:t>
            </a:r>
            <a:r>
              <a:rPr lang="en-US" dirty="0" smtClean="0"/>
              <a:t> </a:t>
            </a:r>
            <a:r>
              <a:rPr lang="en-US" dirty="0"/>
              <a:t>Conditional analysis. Conditioning for the effect of DBR1 +A </a:t>
            </a:r>
            <a:r>
              <a:rPr lang="en-US" dirty="0" smtClean="0"/>
              <a:t>+DPB1 allel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494008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482</Words>
  <Application>Microsoft Office PowerPoint</Application>
  <PresentationFormat>Widescreen</PresentationFormat>
  <Paragraphs>13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OMRF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o Molineros, PhD</dc:creator>
  <cp:lastModifiedBy>Julio Molineros, PhD</cp:lastModifiedBy>
  <cp:revision>2</cp:revision>
  <dcterms:created xsi:type="dcterms:W3CDTF">2019-03-18T18:27:05Z</dcterms:created>
  <dcterms:modified xsi:type="dcterms:W3CDTF">2019-03-18T18:48:27Z</dcterms:modified>
</cp:coreProperties>
</file>